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4" autoAdjust="0"/>
    <p:restoredTop sz="94660"/>
  </p:normalViewPr>
  <p:slideViewPr>
    <p:cSldViewPr snapToGrid="0">
      <p:cViewPr varScale="1">
        <p:scale>
          <a:sx n="85" d="100"/>
          <a:sy n="85" d="100"/>
        </p:scale>
        <p:origin x="96" y="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36E4E4-FDBF-4BAF-923D-B07AA79D15C7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AF6462-4D84-4D07-9C13-D640A48AE40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06583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7D6FC15-F858-4708-90DC-362EB1B01C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463BB04-A62B-4D6B-92D3-D8782332D5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1B69B67-A0AB-47A7-8022-764975025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04C74BF-F73F-4781-9AAC-0D327B46A3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C3E0CF2-2B74-466A-AC42-BA9D4EDDA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3493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986065F-E84B-41E7-B975-57E3690674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A09541E-3E0A-4EFA-881D-AF701B9F0E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F86FF3C-079A-4CAB-86A1-3C18A1D2F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872DED9-5114-4A8C-809A-AFAD5A3C0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3A3B836-B5E6-40E8-904E-E6B6859E3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2579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70829AC-1E19-49CD-9724-FB0ECCD5F0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05C92CF-5543-4A43-874D-E6D99FBE6A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18485DE-58B0-4036-866F-D137AA0CA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0AF8940-DDD9-48CA-8C9E-886E4B66F2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4534A15-4BDB-4228-AAE6-1A8D1C7D8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1977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59EB4CF-FFA4-4E8D-A0FF-A289A33C31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5BB3580-684F-4801-8397-F7B770B31D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3E7593F-8735-4ECF-9CA3-B34CC6474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61309BE-BDCA-4781-9B8A-3D7C6838E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2551CD6-3BD0-45FC-AF57-001A0C89E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3620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DDA70A1-2B5A-424D-B313-263895AC0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EE66B70-F323-4F1E-AF03-198A8A17C0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35B3F53-C335-4CDA-A264-BDD144B27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0741D1E-4A3D-4068-B95D-FBD199991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97F7260-7BF7-4728-A6C9-67ACAFD61B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3533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699BAE1-155E-4C29-BA2A-2F8AA17D83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66218CE-F7B1-4077-9189-A55B092067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F738B65-DEC8-4A69-8648-2AEB85806F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016CE92-7636-4930-9E55-65F9E2DFA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060142C-D154-4F67-9EAF-5E2D3A12F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A2739DF-F8DD-461C-B680-15BCD751B1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3736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F90752-BA66-43A6-9FFA-6A24A523AC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FF17D51-E612-4FD3-BF8E-2281FF5E0B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A200293-557C-4AB6-B1F5-5DD759D752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BD11A45F-8C02-4B9F-9558-71DF3F277D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D2790A03-613E-49AD-AD54-70A13D744C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A2130F50-9264-4574-9729-C961B7721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2ABEAFB-349D-4BBE-895D-C7DB3513B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BE1420CE-9114-4F37-8A51-B7EF7B61E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8891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ECA343E-D3B1-409F-8E67-61D5036CCC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4A407BE0-C7EC-42AD-9D41-06A9C47F8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0242D94-039C-454B-9523-C3B6FF371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7189183-3EFD-4CF1-AE48-7C155D253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72756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56C9269E-055E-4302-9BC0-54438D370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0E34AD1-2829-4FA4-A482-BC064D9A7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67BFCBE-10A7-4FA6-8293-710108A1F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448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57C0054-5B5F-4FC1-9065-DA8345B74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D8A47AD-1635-42A1-97A5-CD3283BDA3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A5B16D9-F2DC-41EF-B370-5F01E10AB9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09CF739-F581-4690-A904-B436288E1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3D19A64-2BD9-4C5A-B3C1-8B38999F7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002E33F-B69A-4FDA-8F28-7ED859505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9391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DA16CFB-3E89-4998-A819-1417D2490C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F6342A0-451A-46BA-B33C-DAA3787FEC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B528A07-4C79-44B6-BCBD-C2FE702917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87A810D-782D-43B8-967B-85359A3795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CFC7C0B-0871-40D0-B68F-D45C837B9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9AB4DD4-40A0-4802-AB3C-A4FF4C6C4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8530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B0EAE5B-756D-480F-B36D-516022C13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08DD879-29DA-4581-A906-46FF1B9A39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E821990-830E-44EC-BD3F-82A7CB2F1B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59765-0EE4-4D1E-A80B-C48AED4C80BC}" type="datetimeFigureOut">
              <a:rPr lang="ko-KR" altLang="en-US" smtClean="0"/>
              <a:t>2020-10-2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250E6E5-6D9A-4419-AC23-A84BBF6712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5AE5F51-2E61-442E-9631-C937116916F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AA6B3C-28BF-4CEA-A376-68E8F10D528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1847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Object 29">
            <a:extLst>
              <a:ext uri="{FF2B5EF4-FFF2-40B4-BE49-F238E27FC236}">
                <a16:creationId xmlns:a16="http://schemas.microsoft.com/office/drawing/2014/main" id="{7E490B1E-FC39-4F6B-B85E-509035D8B8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2403352"/>
              </p:ext>
            </p:extLst>
          </p:nvPr>
        </p:nvGraphicFramePr>
        <p:xfrm>
          <a:off x="2952263" y="1423588"/>
          <a:ext cx="2479675" cy="25355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Image" r:id="rId3" imgW="3542857" imgH="3809524" progId="Photoshop.Image.7">
                  <p:embed/>
                </p:oleObj>
              </mc:Choice>
              <mc:Fallback>
                <p:oleObj name="Image" r:id="rId3" imgW="3542857" imgH="3809524" progId="Photoshop.Image.7">
                  <p:embed/>
                  <p:pic>
                    <p:nvPicPr>
                      <p:cNvPr id="3074" name="Object 29">
                        <a:extLst>
                          <a:ext uri="{FF2B5EF4-FFF2-40B4-BE49-F238E27FC236}">
                            <a16:creationId xmlns:a16="http://schemas.microsoft.com/office/drawing/2014/main" id="{8EC3B299-BEF9-48DA-8BB3-F23EC0DAC7A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52263" y="1423588"/>
                        <a:ext cx="2479675" cy="2535576"/>
                      </a:xfrm>
                      <a:prstGeom prst="rect">
                        <a:avLst/>
                      </a:prstGeom>
                      <a:noFill/>
                      <a:ln w="28575">
                        <a:noFill/>
                        <a:miter lim="800000"/>
                        <a:headEnd/>
                        <a:tailEnd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0DE4C726-9F6A-4707-8B87-0DE1FAA44E08}"/>
              </a:ext>
            </a:extLst>
          </p:cNvPr>
          <p:cNvSpPr txBox="1"/>
          <p:nvPr/>
        </p:nvSpPr>
        <p:spPr>
          <a:xfrm>
            <a:off x="189664" y="265682"/>
            <a:ext cx="73792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800" b="1" dirty="0"/>
              <a:t>Fig. 2. Original file of Western blot result </a:t>
            </a:r>
            <a:endParaRPr lang="ko-KR" altLang="en-US" sz="2800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B72A710-3D37-422D-84DA-290D347945F2}"/>
              </a:ext>
            </a:extLst>
          </p:cNvPr>
          <p:cNvSpPr txBox="1"/>
          <p:nvPr/>
        </p:nvSpPr>
        <p:spPr>
          <a:xfrm>
            <a:off x="1282964" y="4518134"/>
            <a:ext cx="67707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We cut the rec-</a:t>
            </a:r>
            <a:r>
              <a:rPr lang="en-US" altLang="ko-KR" b="1" dirty="0" err="1"/>
              <a:t>eCG</a:t>
            </a:r>
            <a:r>
              <a:rPr lang="en-US" altLang="ko-KR" b="1" dirty="0"/>
              <a:t> lane 1 and 2 in the total western blot. </a:t>
            </a:r>
          </a:p>
          <a:p>
            <a:r>
              <a:rPr lang="en-US" altLang="ko-KR" b="1" dirty="0"/>
              <a:t>And the part was added into the Fig. 2.</a:t>
            </a:r>
            <a:endParaRPr lang="ko-KR" altLang="en-US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59C4555-1215-4884-B86D-47E3BBB08C36}"/>
              </a:ext>
            </a:extLst>
          </p:cNvPr>
          <p:cNvSpPr txBox="1"/>
          <p:nvPr/>
        </p:nvSpPr>
        <p:spPr>
          <a:xfrm>
            <a:off x="3024554" y="1086262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1  2</a:t>
            </a:r>
            <a:endParaRPr lang="ko-KR" altLang="en-US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24A3E97-FA85-4016-91D8-70C3FA440260}"/>
              </a:ext>
            </a:extLst>
          </p:cNvPr>
          <p:cNvSpPr txBox="1"/>
          <p:nvPr/>
        </p:nvSpPr>
        <p:spPr>
          <a:xfrm>
            <a:off x="2956820" y="3860798"/>
            <a:ext cx="3817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-</a:t>
            </a:r>
            <a:endParaRPr lang="ko-KR" altLang="en-US" sz="2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77B19B4-5209-4FED-8A73-E2602AE5F8A1}"/>
              </a:ext>
            </a:extLst>
          </p:cNvPr>
          <p:cNvSpPr txBox="1"/>
          <p:nvPr/>
        </p:nvSpPr>
        <p:spPr>
          <a:xfrm>
            <a:off x="3188243" y="3866441"/>
            <a:ext cx="3817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/>
              <a:t>+</a:t>
            </a:r>
            <a:endParaRPr lang="ko-KR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96095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39</Words>
  <Application>Microsoft Office PowerPoint</Application>
  <PresentationFormat>와이드스크린</PresentationFormat>
  <Paragraphs>6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Office 테마</vt:lpstr>
      <vt:lpstr>Imag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hkang</dc:creator>
  <cp:lastModifiedBy>mhkang</cp:lastModifiedBy>
  <cp:revision>6</cp:revision>
  <dcterms:created xsi:type="dcterms:W3CDTF">2020-10-22T05:54:02Z</dcterms:created>
  <dcterms:modified xsi:type="dcterms:W3CDTF">2020-10-22T07:37:43Z</dcterms:modified>
</cp:coreProperties>
</file>